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51D0EC9-3C02-4A4D-8381-5EF00E90D948}" v="9" dt="2020-06-29T10:42:57.2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8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156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af Hellwinkel" userId="0aad6e210574ea5c" providerId="LiveId" clId="{551D0EC9-3C02-4A4D-8381-5EF00E90D948}"/>
    <pc:docChg chg="custSel modSld">
      <pc:chgData name="Olaf Hellwinkel" userId="0aad6e210574ea5c" providerId="LiveId" clId="{551D0EC9-3C02-4A4D-8381-5EF00E90D948}" dt="2020-06-30T08:02:28.845" v="751" actId="114"/>
      <pc:docMkLst>
        <pc:docMk/>
      </pc:docMkLst>
      <pc:sldChg chg="addSp delSp modSp mod">
        <pc:chgData name="Olaf Hellwinkel" userId="0aad6e210574ea5c" providerId="LiveId" clId="{551D0EC9-3C02-4A4D-8381-5EF00E90D948}" dt="2020-06-30T08:02:28.845" v="751" actId="114"/>
        <pc:sldMkLst>
          <pc:docMk/>
          <pc:sldMk cId="5706264" sldId="256"/>
        </pc:sldMkLst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5" creationId="{09E0C965-99AD-49CC-A72D-F77AF12C35D8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6" creationId="{2C732100-C3BD-4AAB-A1C4-43BBD02F278D}"/>
          </ac:spMkLst>
        </pc:spChg>
        <pc:spChg chg="mod">
          <ac:chgData name="Olaf Hellwinkel" userId="0aad6e210574ea5c" providerId="LiveId" clId="{551D0EC9-3C02-4A4D-8381-5EF00E90D948}" dt="2020-06-29T10:38:33.786" v="471" actId="1076"/>
          <ac:spMkLst>
            <pc:docMk/>
            <pc:sldMk cId="5706264" sldId="256"/>
            <ac:spMk id="7" creationId="{E216BBA9-0E89-497D-A1E8-62237A1A27EF}"/>
          </ac:spMkLst>
        </pc:spChg>
        <pc:spChg chg="mod">
          <ac:chgData name="Olaf Hellwinkel" userId="0aad6e210574ea5c" providerId="LiveId" clId="{551D0EC9-3C02-4A4D-8381-5EF00E90D948}" dt="2020-06-29T10:40:11.915" v="563" actId="1038"/>
          <ac:spMkLst>
            <pc:docMk/>
            <pc:sldMk cId="5706264" sldId="256"/>
            <ac:spMk id="8" creationId="{D6E019E7-5B7E-4D6E-8DC4-BE1F2B973C1B}"/>
          </ac:spMkLst>
        </pc:spChg>
        <pc:spChg chg="mod">
          <ac:chgData name="Olaf Hellwinkel" userId="0aad6e210574ea5c" providerId="LiveId" clId="{551D0EC9-3C02-4A4D-8381-5EF00E90D948}" dt="2020-06-29T10:40:03.792" v="559" actId="1035"/>
          <ac:spMkLst>
            <pc:docMk/>
            <pc:sldMk cId="5706264" sldId="256"/>
            <ac:spMk id="9" creationId="{996D93C0-1603-41DE-BD98-703BCB424AD5}"/>
          </ac:spMkLst>
        </pc:spChg>
        <pc:spChg chg="mod">
          <ac:chgData name="Olaf Hellwinkel" userId="0aad6e210574ea5c" providerId="LiveId" clId="{551D0EC9-3C02-4A4D-8381-5EF00E90D948}" dt="2020-06-29T10:40:03.792" v="559" actId="1035"/>
          <ac:spMkLst>
            <pc:docMk/>
            <pc:sldMk cId="5706264" sldId="256"/>
            <ac:spMk id="10" creationId="{C6127E8E-F373-4DC3-99C6-1379E3DBEC7D}"/>
          </ac:spMkLst>
        </pc:spChg>
        <pc:spChg chg="mod">
          <ac:chgData name="Olaf Hellwinkel" userId="0aad6e210574ea5c" providerId="LiveId" clId="{551D0EC9-3C02-4A4D-8381-5EF00E90D948}" dt="2020-06-30T08:02:19.143" v="749" actId="114"/>
          <ac:spMkLst>
            <pc:docMk/>
            <pc:sldMk cId="5706264" sldId="256"/>
            <ac:spMk id="11" creationId="{A431AB6A-67B0-485F-BA6E-B8FF08C588C3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3" creationId="{471FDF76-4FA7-4494-851A-53475FD42B0C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4" creationId="{1DF3A9F8-5E5D-4AE7-87B7-6852D291336A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5" creationId="{087D0A6F-41FD-480F-A5A6-6D792536DEE9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6" creationId="{02C29493-21ED-4891-8D64-0203219D1C46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7" creationId="{F03F8BBD-12B0-4514-BE4A-2D33CF906B8E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18" creationId="{53427C70-442B-41C5-836B-B599A4106FE2}"/>
          </ac:spMkLst>
        </pc:spChg>
        <pc:spChg chg="mod">
          <ac:chgData name="Olaf Hellwinkel" userId="0aad6e210574ea5c" providerId="LiveId" clId="{551D0EC9-3C02-4A4D-8381-5EF00E90D948}" dt="2020-06-30T08:02:15.199" v="748" actId="114"/>
          <ac:spMkLst>
            <pc:docMk/>
            <pc:sldMk cId="5706264" sldId="256"/>
            <ac:spMk id="19" creationId="{0BB0808F-4350-4BD5-BCCB-A4A2273E8FAD}"/>
          </ac:spMkLst>
        </pc:spChg>
        <pc:spChg chg="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20" creationId="{C1D9A901-F575-4DA3-8D66-C1E4B0AEAB3B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23" creationId="{8859A348-DCD8-496E-9C88-5B2E5B200851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24" creationId="{B8AD60A7-DF79-4F99-9588-B5F24D14BFD6}"/>
          </ac:spMkLst>
        </pc:spChg>
        <pc:spChg chg="add mod">
          <ac:chgData name="Olaf Hellwinkel" userId="0aad6e210574ea5c" providerId="LiveId" clId="{551D0EC9-3C02-4A4D-8381-5EF00E90D948}" dt="2020-06-29T10:43:57.242" v="622" actId="1076"/>
          <ac:spMkLst>
            <pc:docMk/>
            <pc:sldMk cId="5706264" sldId="256"/>
            <ac:spMk id="25" creationId="{012A6B5F-766B-447E-B0C7-20FCF827E7EF}"/>
          </ac:spMkLst>
        </pc:spChg>
        <pc:spChg chg="add mod">
          <ac:chgData name="Olaf Hellwinkel" userId="0aad6e210574ea5c" providerId="LiveId" clId="{551D0EC9-3C02-4A4D-8381-5EF00E90D948}" dt="2020-06-29T10:44:00.645" v="623" actId="1076"/>
          <ac:spMkLst>
            <pc:docMk/>
            <pc:sldMk cId="5706264" sldId="256"/>
            <ac:spMk id="26" creationId="{2E32DA4C-EC6B-45F7-8595-5BD3F50CFE70}"/>
          </ac:spMkLst>
        </pc:spChg>
        <pc:spChg chg="add mod">
          <ac:chgData name="Olaf Hellwinkel" userId="0aad6e210574ea5c" providerId="LiveId" clId="{551D0EC9-3C02-4A4D-8381-5EF00E90D948}" dt="2020-06-29T10:45:00.499" v="686" actId="1036"/>
          <ac:spMkLst>
            <pc:docMk/>
            <pc:sldMk cId="5706264" sldId="256"/>
            <ac:spMk id="27" creationId="{79FB1D6E-4C54-40F1-8C6A-C6CBD3151EF2}"/>
          </ac:spMkLst>
        </pc:spChg>
        <pc:spChg chg="add mod">
          <ac:chgData name="Olaf Hellwinkel" userId="0aad6e210574ea5c" providerId="LiveId" clId="{551D0EC9-3C02-4A4D-8381-5EF00E90D948}" dt="2020-06-29T10:45:08.470" v="719" actId="1035"/>
          <ac:spMkLst>
            <pc:docMk/>
            <pc:sldMk cId="5706264" sldId="256"/>
            <ac:spMk id="28" creationId="{2FD9C5E1-9FA2-4F51-B660-18433D2F1CCE}"/>
          </ac:spMkLst>
        </pc:spChg>
        <pc:spChg chg="add mod">
          <ac:chgData name="Olaf Hellwinkel" userId="0aad6e210574ea5c" providerId="LiveId" clId="{551D0EC9-3C02-4A4D-8381-5EF00E90D948}" dt="2020-06-30T08:02:28.845" v="751" actId="114"/>
          <ac:spMkLst>
            <pc:docMk/>
            <pc:sldMk cId="5706264" sldId="256"/>
            <ac:spMk id="29" creationId="{2C2AA755-FF86-4C25-927E-478594EE9C4D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1" creationId="{E64E323B-8BD9-49C0-A3A8-77E261265E4B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2" creationId="{F41C0009-59E6-4CD3-99D4-58DEE543473D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3" creationId="{6157D97A-FA1B-46A4-B79E-630FAFF3D935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4" creationId="{55B48BF4-017C-4031-AAFC-FF476598F3C9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5" creationId="{F4C140EE-F756-41EE-8FEC-82E52B90E858}"/>
          </ac:spMkLst>
        </pc:spChg>
        <pc:spChg chg="add mod">
          <ac:chgData name="Olaf Hellwinkel" userId="0aad6e210574ea5c" providerId="LiveId" clId="{551D0EC9-3C02-4A4D-8381-5EF00E90D948}" dt="2020-06-30T08:02:25.303" v="750" actId="114"/>
          <ac:spMkLst>
            <pc:docMk/>
            <pc:sldMk cId="5706264" sldId="256"/>
            <ac:spMk id="36" creationId="{150CCC78-42AF-4CF7-A85F-87328BBACD9A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7" creationId="{A59CC414-5FE2-4589-8653-F54BF442FE37}"/>
          </ac:spMkLst>
        </pc:spChg>
        <pc:spChg chg="add mod">
          <ac:chgData name="Olaf Hellwinkel" userId="0aad6e210574ea5c" providerId="LiveId" clId="{551D0EC9-3C02-4A4D-8381-5EF00E90D948}" dt="2020-06-24T10:19:37.793" v="386" actId="1035"/>
          <ac:spMkLst>
            <pc:docMk/>
            <pc:sldMk cId="5706264" sldId="256"/>
            <ac:spMk id="38" creationId="{A65A53C6-571B-4E93-9B48-94314DDB8968}"/>
          </ac:spMkLst>
        </pc:spChg>
        <pc:spChg chg="add mod">
          <ac:chgData name="Olaf Hellwinkel" userId="0aad6e210574ea5c" providerId="LiveId" clId="{551D0EC9-3C02-4A4D-8381-5EF00E90D948}" dt="2020-06-24T10:19:56.559" v="412" actId="1036"/>
          <ac:spMkLst>
            <pc:docMk/>
            <pc:sldMk cId="5706264" sldId="256"/>
            <ac:spMk id="39" creationId="{69D315B3-8286-4B93-94F2-657CB221BEC1}"/>
          </ac:spMkLst>
        </pc:spChg>
        <pc:picChg chg="add mod ord modCrop">
          <ac:chgData name="Olaf Hellwinkel" userId="0aad6e210574ea5c" providerId="LiveId" clId="{551D0EC9-3C02-4A4D-8381-5EF00E90D948}" dt="2020-06-29T10:38:28.227" v="470" actId="167"/>
          <ac:picMkLst>
            <pc:docMk/>
            <pc:sldMk cId="5706264" sldId="256"/>
            <ac:picMk id="2" creationId="{03BE04E8-DEB5-4A73-B54E-E4BE15E3D8CB}"/>
          </ac:picMkLst>
        </pc:picChg>
        <pc:picChg chg="add mod ord modCrop">
          <ac:chgData name="Olaf Hellwinkel" userId="0aad6e210574ea5c" providerId="LiveId" clId="{551D0EC9-3C02-4A4D-8381-5EF00E90D948}" dt="2020-06-29T10:43:43.439" v="620" actId="167"/>
          <ac:picMkLst>
            <pc:docMk/>
            <pc:sldMk cId="5706264" sldId="256"/>
            <ac:picMk id="3" creationId="{49E35E3B-786D-4F2A-B378-F7BDE6B9A0D1}"/>
          </ac:picMkLst>
        </pc:picChg>
        <pc:picChg chg="del mod">
          <ac:chgData name="Olaf Hellwinkel" userId="0aad6e210574ea5c" providerId="LiveId" clId="{551D0EC9-3C02-4A4D-8381-5EF00E90D948}" dt="2020-06-29T10:38:18.995" v="428" actId="478"/>
          <ac:picMkLst>
            <pc:docMk/>
            <pc:sldMk cId="5706264" sldId="256"/>
            <ac:picMk id="4" creationId="{FA9270CE-A2E4-4C80-91F2-12D400A291B6}"/>
          </ac:picMkLst>
        </pc:picChg>
        <pc:picChg chg="mod">
          <ac:chgData name="Olaf Hellwinkel" userId="0aad6e210574ea5c" providerId="LiveId" clId="{551D0EC9-3C02-4A4D-8381-5EF00E90D948}" dt="2020-06-24T10:19:37.793" v="386" actId="1035"/>
          <ac:picMkLst>
            <pc:docMk/>
            <pc:sldMk cId="5706264" sldId="256"/>
            <ac:picMk id="12" creationId="{33164764-FA75-47B3-9CA3-1C3A5E18EF4F}"/>
          </ac:picMkLst>
        </pc:picChg>
        <pc:picChg chg="add del mod modCrop">
          <ac:chgData name="Olaf Hellwinkel" userId="0aad6e210574ea5c" providerId="LiveId" clId="{551D0EC9-3C02-4A4D-8381-5EF00E90D948}" dt="2020-06-29T10:42:27.537" v="564" actId="478"/>
          <ac:picMkLst>
            <pc:docMk/>
            <pc:sldMk cId="5706264" sldId="256"/>
            <ac:picMk id="22" creationId="{BB9C6D17-532D-4891-A262-277296AC2851}"/>
          </ac:picMkLst>
        </pc:picChg>
        <pc:picChg chg="add mod modCrop">
          <ac:chgData name="Olaf Hellwinkel" userId="0aad6e210574ea5c" providerId="LiveId" clId="{551D0EC9-3C02-4A4D-8381-5EF00E90D948}" dt="2020-06-24T10:19:37.793" v="386" actId="1035"/>
          <ac:picMkLst>
            <pc:docMk/>
            <pc:sldMk cId="5706264" sldId="256"/>
            <ac:picMk id="30" creationId="{4E2231AE-7056-4701-9410-E475ECA1ECC5}"/>
          </ac:picMkLst>
        </pc:picChg>
        <pc:cxnChg chg="mod">
          <ac:chgData name="Olaf Hellwinkel" userId="0aad6e210574ea5c" providerId="LiveId" clId="{551D0EC9-3C02-4A4D-8381-5EF00E90D948}" dt="2020-06-24T10:19:37.793" v="386" actId="1035"/>
          <ac:cxnSpMkLst>
            <pc:docMk/>
            <pc:sldMk cId="5706264" sldId="256"/>
            <ac:cxnSpMk id="21" creationId="{1BBD0CF6-D5DC-419E-9395-AF0B19AF58A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7716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5113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2993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5274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1560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6520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746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3186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4817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2047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9669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5F0AB-AF11-442A-B79E-AEA5D88A695D}" type="datetimeFigureOut">
              <a:rPr lang="de-DE" smtClean="0"/>
              <a:t>02.04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1968-55B4-44C8-AEDD-333C6C259F5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3916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03BE04E8-DEB5-4A73-B54E-E4BE15E3D8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614" t="6122" r="33139" b="8834"/>
          <a:stretch/>
        </p:blipFill>
        <p:spPr>
          <a:xfrm>
            <a:off x="5198176" y="2235712"/>
            <a:ext cx="2949147" cy="2833068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09E0C965-99AD-49CC-A72D-F77AF12C35D8}"/>
              </a:ext>
            </a:extLst>
          </p:cNvPr>
          <p:cNvSpPr txBox="1"/>
          <p:nvPr/>
        </p:nvSpPr>
        <p:spPr>
          <a:xfrm rot="16200000">
            <a:off x="4008412" y="3350684"/>
            <a:ext cx="2126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Sensitivity</a:t>
            </a:r>
            <a:endParaRPr lang="de-DE" sz="1200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2C732100-C3BD-4AAB-A1C4-43BBD02F278D}"/>
              </a:ext>
            </a:extLst>
          </p:cNvPr>
          <p:cNvSpPr txBox="1"/>
          <p:nvPr/>
        </p:nvSpPr>
        <p:spPr>
          <a:xfrm>
            <a:off x="5807598" y="5034039"/>
            <a:ext cx="2028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1 - </a:t>
            </a:r>
            <a:r>
              <a:rPr lang="de-DE" sz="1200" dirty="0" err="1"/>
              <a:t>Specificity</a:t>
            </a:r>
            <a:endParaRPr lang="de-DE" sz="1200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E216BBA9-0E89-497D-A1E8-62237A1A27EF}"/>
              </a:ext>
            </a:extLst>
          </p:cNvPr>
          <p:cNvSpPr txBox="1"/>
          <p:nvPr/>
        </p:nvSpPr>
        <p:spPr>
          <a:xfrm>
            <a:off x="5526326" y="2457744"/>
            <a:ext cx="1190446" cy="261610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100" b="1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100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D6E019E7-5B7E-4D6E-8DC4-BE1F2B973C1B}"/>
              </a:ext>
            </a:extLst>
          </p:cNvPr>
          <p:cNvSpPr txBox="1"/>
          <p:nvPr/>
        </p:nvSpPr>
        <p:spPr>
          <a:xfrm>
            <a:off x="6887163" y="3655738"/>
            <a:ext cx="1109542" cy="261610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100" b="1" dirty="0" err="1">
                <a:solidFill>
                  <a:schemeClr val="accent2">
                    <a:lumMod val="75000"/>
                  </a:schemeClr>
                </a:solidFill>
              </a:rPr>
              <a:t>rel.ECM-loss</a:t>
            </a:r>
            <a:r>
              <a:rPr lang="de-DE" sz="1100" b="1" dirty="0">
                <a:solidFill>
                  <a:schemeClr val="accent2">
                    <a:lumMod val="75000"/>
                  </a:schemeClr>
                </a:solidFill>
              </a:rPr>
              <a:t>/d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996D93C0-1603-41DE-BD98-703BCB424AD5}"/>
              </a:ext>
            </a:extLst>
          </p:cNvPr>
          <p:cNvSpPr txBox="1"/>
          <p:nvPr/>
        </p:nvSpPr>
        <p:spPr>
          <a:xfrm>
            <a:off x="7116110" y="3938735"/>
            <a:ext cx="1684990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1">
                    <a:lumMod val="60000"/>
                    <a:lumOff val="40000"/>
                  </a:schemeClr>
                </a:solidFill>
              </a:rPr>
              <a:t>rel.ECD-loss</a:t>
            </a:r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/d)= 0.763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C6127E8E-F373-4DC3-99C6-1379E3DBEC7D}"/>
              </a:ext>
            </a:extLst>
          </p:cNvPr>
          <p:cNvSpPr txBox="1"/>
          <p:nvPr/>
        </p:nvSpPr>
        <p:spPr>
          <a:xfrm>
            <a:off x="7116110" y="4110185"/>
            <a:ext cx="1763806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AUC(</a:t>
            </a:r>
            <a:r>
              <a:rPr lang="de-DE" sz="1000" dirty="0" err="1">
                <a:solidFill>
                  <a:schemeClr val="accent2">
                    <a:lumMod val="75000"/>
                  </a:schemeClr>
                </a:solidFill>
              </a:rPr>
              <a:t>rel.ECM-loss</a:t>
            </a:r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/d)= 0.37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A431AB6A-67B0-485F-BA6E-B8FF08C588C3}"/>
              </a:ext>
            </a:extLst>
          </p:cNvPr>
          <p:cNvSpPr txBox="1"/>
          <p:nvPr/>
        </p:nvSpPr>
        <p:spPr>
          <a:xfrm>
            <a:off x="7527192" y="4325599"/>
            <a:ext cx="528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N= 75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xmlns="" id="{33164764-FA75-47B3-9CA3-1C3A5E18EF4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628" t="6150" r="33400" b="13690"/>
          <a:stretch/>
        </p:blipFill>
        <p:spPr>
          <a:xfrm>
            <a:off x="1704540" y="2259576"/>
            <a:ext cx="3017359" cy="2856388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471FDF76-4FA7-4494-851A-53475FD42B0C}"/>
              </a:ext>
            </a:extLst>
          </p:cNvPr>
          <p:cNvSpPr txBox="1"/>
          <p:nvPr/>
        </p:nvSpPr>
        <p:spPr>
          <a:xfrm rot="16200000">
            <a:off x="491773" y="3352291"/>
            <a:ext cx="2126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/>
              <a:t>Sensitivity</a:t>
            </a:r>
            <a:endParaRPr lang="de-DE" sz="1200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1DF3A9F8-5E5D-4AE7-87B7-6852D291336A}"/>
              </a:ext>
            </a:extLst>
          </p:cNvPr>
          <p:cNvSpPr txBox="1"/>
          <p:nvPr/>
        </p:nvSpPr>
        <p:spPr>
          <a:xfrm>
            <a:off x="2290960" y="5035646"/>
            <a:ext cx="2028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1 - </a:t>
            </a:r>
            <a:r>
              <a:rPr lang="de-DE" sz="1200" dirty="0" err="1"/>
              <a:t>Specificity</a:t>
            </a:r>
            <a:endParaRPr lang="de-DE" sz="12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087D0A6F-41FD-480F-A5A6-6D792536DEE9}"/>
              </a:ext>
            </a:extLst>
          </p:cNvPr>
          <p:cNvSpPr txBox="1"/>
          <p:nvPr/>
        </p:nvSpPr>
        <p:spPr>
          <a:xfrm>
            <a:off x="2481071" y="2369837"/>
            <a:ext cx="480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ECD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02C29493-21ED-4891-8D64-0203219D1C46}"/>
              </a:ext>
            </a:extLst>
          </p:cNvPr>
          <p:cNvSpPr txBox="1"/>
          <p:nvPr/>
        </p:nvSpPr>
        <p:spPr>
          <a:xfrm>
            <a:off x="2958322" y="2825304"/>
            <a:ext cx="480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solidFill>
                  <a:schemeClr val="accent2">
                    <a:lumMod val="75000"/>
                  </a:schemeClr>
                </a:solidFill>
              </a:rPr>
              <a:t>ECM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F03F8BBD-12B0-4514-BE4A-2D33CF906B8E}"/>
              </a:ext>
            </a:extLst>
          </p:cNvPr>
          <p:cNvSpPr txBox="1"/>
          <p:nvPr/>
        </p:nvSpPr>
        <p:spPr>
          <a:xfrm>
            <a:off x="3305704" y="3902042"/>
            <a:ext cx="1103016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AUC(ECD)= 0.796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53427C70-442B-41C5-836B-B599A4106FE2}"/>
              </a:ext>
            </a:extLst>
          </p:cNvPr>
          <p:cNvSpPr txBox="1"/>
          <p:nvPr/>
        </p:nvSpPr>
        <p:spPr>
          <a:xfrm>
            <a:off x="3305703" y="4083017"/>
            <a:ext cx="1194005" cy="246221"/>
          </a:xfrm>
          <a:prstGeom prst="rect">
            <a:avLst/>
          </a:prstGeom>
          <a:solidFill>
            <a:srgbClr val="FFFFFF">
              <a:alpha val="50196"/>
            </a:srgbClr>
          </a:solidFill>
        </p:spPr>
        <p:txBody>
          <a:bodyPr wrap="square" rtlCol="0">
            <a:spAutoFit/>
          </a:bodyPr>
          <a:lstStyle/>
          <a:p>
            <a:r>
              <a:rPr lang="de-DE" sz="1000" dirty="0">
                <a:solidFill>
                  <a:schemeClr val="accent2">
                    <a:lumMod val="75000"/>
                  </a:schemeClr>
                </a:solidFill>
              </a:rPr>
              <a:t>AUC(ECM)= 0.739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0BB0808F-4350-4BD5-BCCB-A4A2273E8FAD}"/>
              </a:ext>
            </a:extLst>
          </p:cNvPr>
          <p:cNvSpPr txBox="1"/>
          <p:nvPr/>
        </p:nvSpPr>
        <p:spPr>
          <a:xfrm>
            <a:off x="3477154" y="4336531"/>
            <a:ext cx="584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/>
              <a:t>N= 196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C1D9A901-F575-4DA3-8D66-C1E4B0AEAB3B}"/>
              </a:ext>
            </a:extLst>
          </p:cNvPr>
          <p:cNvSpPr txBox="1"/>
          <p:nvPr/>
        </p:nvSpPr>
        <p:spPr>
          <a:xfrm>
            <a:off x="253229" y="3199719"/>
            <a:ext cx="14136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Corneas</a:t>
            </a:r>
            <a:r>
              <a:rPr lang="de-DE" sz="1200" b="1" dirty="0"/>
              <a:t> </a:t>
            </a:r>
          </a:p>
          <a:p>
            <a:r>
              <a:rPr lang="de-DE" sz="1200" b="1" dirty="0" err="1"/>
              <a:t>from</a:t>
            </a:r>
            <a:r>
              <a:rPr lang="de-DE" sz="1200" b="1" dirty="0"/>
              <a:t> </a:t>
            </a:r>
            <a:r>
              <a:rPr lang="de-DE" sz="1200" b="1" dirty="0" err="1"/>
              <a:t>donors</a:t>
            </a:r>
            <a:endParaRPr lang="de-DE" sz="1200" b="1" dirty="0"/>
          </a:p>
          <a:p>
            <a:r>
              <a:rPr lang="de-DE" sz="1200" b="1" dirty="0"/>
              <a:t>at </a:t>
            </a:r>
            <a:r>
              <a:rPr lang="de-DE" sz="1200" b="1" dirty="0" err="1"/>
              <a:t>age</a:t>
            </a:r>
            <a:r>
              <a:rPr lang="de-DE" sz="1200" b="1" dirty="0"/>
              <a:t> ≥ 80 </a:t>
            </a:r>
            <a:r>
              <a:rPr lang="de-DE" sz="1200" b="1" dirty="0" err="1"/>
              <a:t>years</a:t>
            </a:r>
            <a:endParaRPr lang="de-DE" sz="1200" b="1" dirty="0"/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xmlns="" id="{69D315B3-8286-4B93-94F2-657CB221BEC1}"/>
              </a:ext>
            </a:extLst>
          </p:cNvPr>
          <p:cNvSpPr txBox="1"/>
          <p:nvPr/>
        </p:nvSpPr>
        <p:spPr>
          <a:xfrm>
            <a:off x="2494997" y="1609570"/>
            <a:ext cx="45483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/>
              <a:t>ROC-</a:t>
            </a:r>
            <a:r>
              <a:rPr lang="de-DE" sz="1200" b="1" dirty="0" err="1"/>
              <a:t>Curves</a:t>
            </a:r>
            <a:r>
              <a:rPr lang="de-DE" sz="1200" b="1" dirty="0"/>
              <a:t> </a:t>
            </a:r>
            <a:r>
              <a:rPr lang="de-DE" sz="1200" b="1" dirty="0" err="1"/>
              <a:t>for</a:t>
            </a:r>
            <a:r>
              <a:rPr lang="de-DE" sz="1200" b="1" dirty="0"/>
              <a:t> </a:t>
            </a:r>
            <a:r>
              <a:rPr lang="de-DE" sz="1200" b="1" dirty="0" err="1"/>
              <a:t>transplantation</a:t>
            </a:r>
            <a:r>
              <a:rPr lang="de-DE" sz="1200" b="1" dirty="0"/>
              <a:t> </a:t>
            </a:r>
          </a:p>
          <a:p>
            <a:pPr algn="ctr"/>
            <a:r>
              <a:rPr lang="de-DE" sz="1200" dirty="0"/>
              <a:t>ECD/ECM and ECD/ECM–</a:t>
            </a:r>
            <a:r>
              <a:rPr lang="de-DE" sz="1200" dirty="0" err="1"/>
              <a:t>Losses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predictors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5706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Olaf Hellwinkel</dc:creator>
  <cp:lastModifiedBy>ADS-User-Augenklinik</cp:lastModifiedBy>
  <cp:revision>2</cp:revision>
  <dcterms:created xsi:type="dcterms:W3CDTF">2020-06-24T09:45:44Z</dcterms:created>
  <dcterms:modified xsi:type="dcterms:W3CDTF">2023-04-02T20:10:33Z</dcterms:modified>
</cp:coreProperties>
</file>